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6858000" cy="9144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86808E-FE93-4EF1-8039-E278AA5768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17E2A2-DEDF-4255-8425-F56D941309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4CBA69-D7DD-4FEB-A57D-7EBDD49A2D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4C39F7-CAFC-4BCE-94A2-75192E2AAE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50C627-A859-4752-91C8-F68725F8A0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804147-0B1A-43AC-AA7D-7BB87EBD8F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7CF83-2138-4C58-95A3-19FBDFE7A0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D4F0A1-418F-4905-A453-B1B60F97B3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900621-DDB6-4D2B-85A8-C80A0CFD85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E4C049-2653-4ECC-B0BB-6E742749FD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194520-F058-492C-9A61-A2A0C4C82F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E9EBD5-3B38-446D-B0C9-650BC54C0F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7000"/>
          </a:bodyPr>
          <a:p>
            <a:pPr marL="298440" indent="-29844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646200" indent="-2484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994320" indent="-19872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392120" indent="-19872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1789920" indent="-19872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1789920" indent="-19872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1789920" indent="-19872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BD3B0A-407A-4813-925E-040E0BAC85E0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55480" y="3855960"/>
            <a:ext cx="5745240" cy="174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Additional file 3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Hybridization intensity maps for genes identified in Figure 1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"/>
          <p:cNvGrpSpPr/>
          <p:nvPr/>
        </p:nvGrpSpPr>
        <p:grpSpPr>
          <a:xfrm>
            <a:off x="380880" y="2057400"/>
            <a:ext cx="6097680" cy="4572000"/>
            <a:chOff x="380880" y="2057400"/>
            <a:chExt cx="6097680" cy="4572000"/>
          </a:xfrm>
        </p:grpSpPr>
        <p:pic>
          <p:nvPicPr>
            <p:cNvPr id="43" name="" descr=""/>
            <p:cNvPicPr/>
            <p:nvPr/>
          </p:nvPicPr>
          <p:blipFill>
            <a:blip r:embed="rId1"/>
            <a:stretch/>
          </p:blipFill>
          <p:spPr>
            <a:xfrm>
              <a:off x="380880" y="2057400"/>
              <a:ext cx="6097680" cy="457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"/>
            <p:cNvSpPr/>
            <p:nvPr/>
          </p:nvSpPr>
          <p:spPr>
            <a:xfrm>
              <a:off x="4214880" y="5257800"/>
              <a:ext cx="152280" cy="914400"/>
            </a:xfrm>
            <a:prstGeom prst="rect">
              <a:avLst/>
            </a:prstGeom>
            <a:noFill/>
            <a:ln w="2844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 flipH="1">
              <a:off x="4498560" y="244800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938760" y="2448000"/>
              <a:ext cx="126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"/>
          <p:cNvGrpSpPr/>
          <p:nvPr/>
        </p:nvGrpSpPr>
        <p:grpSpPr>
          <a:xfrm>
            <a:off x="291960" y="1828800"/>
            <a:ext cx="6097680" cy="4572000"/>
            <a:chOff x="291960" y="1828800"/>
            <a:chExt cx="6097680" cy="4572000"/>
          </a:xfrm>
        </p:grpSpPr>
        <p:pic>
          <p:nvPicPr>
            <p:cNvPr id="48" name="" descr=""/>
            <p:cNvPicPr/>
            <p:nvPr/>
          </p:nvPicPr>
          <p:blipFill>
            <a:blip r:embed="rId1"/>
            <a:stretch/>
          </p:blipFill>
          <p:spPr>
            <a:xfrm>
              <a:off x="291960" y="1828800"/>
              <a:ext cx="6097680" cy="457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"/>
            <p:cNvSpPr/>
            <p:nvPr/>
          </p:nvSpPr>
          <p:spPr>
            <a:xfrm flipH="1">
              <a:off x="2281320" y="5024520"/>
              <a:ext cx="288720" cy="915840"/>
            </a:xfrm>
            <a:prstGeom prst="rect">
              <a:avLst/>
            </a:prstGeom>
            <a:noFill/>
            <a:ln w="2844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"/>
          <p:cNvSpPr/>
          <p:nvPr/>
        </p:nvSpPr>
        <p:spPr>
          <a:xfrm>
            <a:off x="555480" y="4160880"/>
            <a:ext cx="574524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Hybridization intensity maps for genes identified in Figure 1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tretch/>
        </p:blipFill>
        <p:spPr>
          <a:xfrm>
            <a:off x="365040" y="1828800"/>
            <a:ext cx="6097680" cy="4572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304920" y="1828800"/>
            <a:ext cx="6094440" cy="457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" descr=""/>
          <p:cNvPicPr/>
          <p:nvPr/>
        </p:nvPicPr>
        <p:blipFill>
          <a:blip r:embed="rId1"/>
          <a:stretch/>
        </p:blipFill>
        <p:spPr>
          <a:xfrm>
            <a:off x="365040" y="1828800"/>
            <a:ext cx="6097680" cy="4572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452520" y="1828800"/>
            <a:ext cx="6097680" cy="4572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" descr=""/>
          <p:cNvPicPr/>
          <p:nvPr/>
        </p:nvPicPr>
        <p:blipFill>
          <a:blip r:embed="rId1"/>
          <a:stretch/>
        </p:blipFill>
        <p:spPr>
          <a:xfrm>
            <a:off x="603360" y="2185920"/>
            <a:ext cx="6095880" cy="4570560"/>
          </a:xfrm>
          <a:prstGeom prst="rect">
            <a:avLst/>
          </a:prstGeom>
          <a:ln w="0">
            <a:noFill/>
          </a:ln>
        </p:spPr>
      </p:pic>
      <p:sp>
        <p:nvSpPr>
          <p:cNvPr id="56" name=""/>
          <p:cNvSpPr/>
          <p:nvPr/>
        </p:nvSpPr>
        <p:spPr>
          <a:xfrm>
            <a:off x="2513160" y="2367000"/>
            <a:ext cx="7174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KX6-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16T17:22:47Z</dcterms:created>
  <dc:creator>UT M.D. Anderson</dc:creator>
  <dc:description/>
  <dc:language>en-US</dc:language>
  <cp:lastModifiedBy>Ralf Krahe, Ph.D.</cp:lastModifiedBy>
  <cp:lastPrinted>2007-01-31T17:26:47Z</cp:lastPrinted>
  <dcterms:modified xsi:type="dcterms:W3CDTF">2008-03-05T01:02:05Z</dcterms:modified>
  <cp:revision>85</cp:revision>
  <dc:subject/>
  <dc:title>PowerPoint Presentation</dc:title>
</cp:coreProperties>
</file>